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3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52" userDrawn="1">
          <p15:clr>
            <a:srgbClr val="A4A3A4"/>
          </p15:clr>
        </p15:guide>
        <p15:guide id="2" pos="1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7" autoAdjust="0"/>
    <p:restoredTop sz="96723" autoAdjust="0"/>
  </p:normalViewPr>
  <p:slideViewPr>
    <p:cSldViewPr snapToGrid="0" showGuides="1">
      <p:cViewPr varScale="1">
        <p:scale>
          <a:sx n="86" d="100"/>
          <a:sy n="86" d="100"/>
        </p:scale>
        <p:origin x="2844" y="96"/>
      </p:cViewPr>
      <p:guideLst>
        <p:guide orient="horz" pos="2952"/>
        <p:guide pos="19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604066282759431"/>
          <c:y val="5.9823262299097471E-2"/>
          <c:w val="0.70923296901320165"/>
          <c:h val="0.7870605006861451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14</c:f>
              <c:strCache>
                <c:ptCount val="1"/>
                <c:pt idx="0">
                  <c:v>DMSO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35:$I$35</c:f>
                <c:numCache>
                  <c:formatCode>General</c:formatCode>
                  <c:ptCount val="2"/>
                  <c:pt idx="0">
                    <c:v>0.12651057106891131</c:v>
                  </c:pt>
                  <c:pt idx="1">
                    <c:v>0.48312022344614708</c:v>
                  </c:pt>
                </c:numCache>
              </c:numRef>
            </c:plus>
            <c:minus>
              <c:numRef>
                <c:f>Sheet1!$H$35:$I$35</c:f>
                <c:numCache>
                  <c:formatCode>General</c:formatCode>
                  <c:ptCount val="2"/>
                  <c:pt idx="0">
                    <c:v>0.12651057106891131</c:v>
                  </c:pt>
                  <c:pt idx="1">
                    <c:v>0.483120223446147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13:$E$13</c:f>
              <c:strCache>
                <c:ptCount val="2"/>
                <c:pt idx="0">
                  <c:v>RMF</c:v>
                </c:pt>
                <c:pt idx="1">
                  <c:v>CAF5</c:v>
                </c:pt>
              </c:strCache>
            </c:strRef>
          </c:cat>
          <c:val>
            <c:numRef>
              <c:f>Sheet1!$D$14:$E$14</c:f>
              <c:numCache>
                <c:formatCode>General</c:formatCode>
                <c:ptCount val="2"/>
                <c:pt idx="0">
                  <c:v>1</c:v>
                </c:pt>
                <c:pt idx="1">
                  <c:v>3.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01-4157-BE37-86BA79017DC9}"/>
            </c:ext>
          </c:extLst>
        </c:ser>
        <c:ser>
          <c:idx val="1"/>
          <c:order val="1"/>
          <c:tx>
            <c:strRef>
              <c:f>Sheet1!$C$15</c:f>
              <c:strCache>
                <c:ptCount val="1"/>
                <c:pt idx="0">
                  <c:v>GKT 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38:$I$38</c:f>
                <c:numCache>
                  <c:formatCode>General</c:formatCode>
                  <c:ptCount val="2"/>
                  <c:pt idx="0">
                    <c:v>6.1612010250600778E-2</c:v>
                  </c:pt>
                  <c:pt idx="1">
                    <c:v>0.13399344137297825</c:v>
                  </c:pt>
                </c:numCache>
              </c:numRef>
            </c:plus>
            <c:minus>
              <c:numRef>
                <c:f>Sheet1!$H$38:$I$38</c:f>
                <c:numCache>
                  <c:formatCode>General</c:formatCode>
                  <c:ptCount val="2"/>
                  <c:pt idx="0">
                    <c:v>6.1612010250600778E-2</c:v>
                  </c:pt>
                  <c:pt idx="1">
                    <c:v>0.133993441372978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13:$E$13</c:f>
              <c:strCache>
                <c:ptCount val="2"/>
                <c:pt idx="0">
                  <c:v>RMF</c:v>
                </c:pt>
                <c:pt idx="1">
                  <c:v>CAF5</c:v>
                </c:pt>
              </c:strCache>
            </c:strRef>
          </c:cat>
          <c:val>
            <c:numRef>
              <c:f>Sheet1!$D$15:$E$15</c:f>
              <c:numCache>
                <c:formatCode>General</c:formatCode>
                <c:ptCount val="2"/>
                <c:pt idx="0">
                  <c:v>0.67</c:v>
                </c:pt>
                <c:pt idx="1">
                  <c:v>0.9350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B01-4157-BE37-86BA79017D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8"/>
        <c:axId val="1957058992"/>
        <c:axId val="1957058160"/>
      </c:barChart>
      <c:catAx>
        <c:axId val="1957058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7058160"/>
        <c:crosses val="autoZero"/>
        <c:auto val="1"/>
        <c:lblAlgn val="ctr"/>
        <c:lblOffset val="100"/>
        <c:noMultiLvlLbl val="0"/>
      </c:catAx>
      <c:valAx>
        <c:axId val="1957058160"/>
        <c:scaling>
          <c:orientation val="minMax"/>
          <c:max val="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lative Migration (MDA-MB231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70589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2234888549379084"/>
          <c:y val="3.2189796900666832E-2"/>
          <c:w val="0.58195792590164275"/>
          <c:h val="7.333023790224209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23:$I$25</c:f>
                <c:numCache>
                  <c:formatCode>General</c:formatCode>
                  <c:ptCount val="3"/>
                  <c:pt idx="0">
                    <c:v>6.3816993255791071E-2</c:v>
                  </c:pt>
                  <c:pt idx="1">
                    <c:v>6.1102297498200467E-2</c:v>
                  </c:pt>
                  <c:pt idx="2">
                    <c:v>5.2895822947062278E-2</c:v>
                  </c:pt>
                </c:numCache>
              </c:numRef>
            </c:plus>
            <c:minus>
              <c:numRef>
                <c:f>Sheet1!$I$23:$I$26</c:f>
                <c:numCache>
                  <c:formatCode>General</c:formatCode>
                  <c:ptCount val="4"/>
                  <c:pt idx="0">
                    <c:v>6.3816993255791071E-2</c:v>
                  </c:pt>
                  <c:pt idx="1">
                    <c:v>6.1102297498200467E-2</c:v>
                  </c:pt>
                  <c:pt idx="2">
                    <c:v>5.289582294706227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3:$A$25</c:f>
              <c:strCache>
                <c:ptCount val="3"/>
                <c:pt idx="0">
                  <c:v>RMF</c:v>
                </c:pt>
                <c:pt idx="1">
                  <c:v>CAF5</c:v>
                </c:pt>
                <c:pt idx="2">
                  <c:v>CAF5+GKT</c:v>
                </c:pt>
              </c:strCache>
            </c:strRef>
          </c:cat>
          <c:val>
            <c:numRef>
              <c:f>Sheet1!$H$23:$H$25</c:f>
              <c:numCache>
                <c:formatCode>General</c:formatCode>
                <c:ptCount val="3"/>
                <c:pt idx="0">
                  <c:v>0.99999999999999989</c:v>
                </c:pt>
                <c:pt idx="1">
                  <c:v>0.61915977162882019</c:v>
                </c:pt>
                <c:pt idx="2">
                  <c:v>0.273651921323737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33-4494-B4EA-4B571F44D1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986127280"/>
        <c:axId val="1986126864"/>
      </c:barChart>
      <c:catAx>
        <c:axId val="1986127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6126864"/>
        <c:crosses val="autoZero"/>
        <c:auto val="1"/>
        <c:lblAlgn val="ctr"/>
        <c:lblOffset val="100"/>
        <c:noMultiLvlLbl val="0"/>
      </c:catAx>
      <c:valAx>
        <c:axId val="19861268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lative</a:t>
                </a:r>
                <a:r>
                  <a:rPr lang="en-US" baseline="0"/>
                  <a:t> collagen disc area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61272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aw Data-5 Hour'!$I$26</c:f>
              <c:strCache>
                <c:ptCount val="1"/>
                <c:pt idx="0">
                  <c:v>DMSO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w Data-5 Hour'!$L$26:$M$26</c:f>
                <c:numCache>
                  <c:formatCode>General</c:formatCode>
                  <c:ptCount val="2"/>
                  <c:pt idx="0">
                    <c:v>7.9472742355388995E-2</c:v>
                  </c:pt>
                  <c:pt idx="1">
                    <c:v>5.5522408410420686E-2</c:v>
                  </c:pt>
                </c:numCache>
              </c:numRef>
            </c:plus>
            <c:minus>
              <c:numRef>
                <c:f>'Raw Data-5 Hour'!$L$26:$M$26</c:f>
                <c:numCache>
                  <c:formatCode>General</c:formatCode>
                  <c:ptCount val="2"/>
                  <c:pt idx="0">
                    <c:v>7.9472742355388995E-2</c:v>
                  </c:pt>
                  <c:pt idx="1">
                    <c:v>5.552240841042068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w Data-5 Hour'!$J$25:$K$25</c:f>
              <c:strCache>
                <c:ptCount val="2"/>
                <c:pt idx="0">
                  <c:v>RMF</c:v>
                </c:pt>
                <c:pt idx="1">
                  <c:v>CAF5</c:v>
                </c:pt>
              </c:strCache>
            </c:strRef>
          </c:cat>
          <c:val>
            <c:numRef>
              <c:f>'Raw Data-5 Hour'!$J$26:$K$26</c:f>
              <c:numCache>
                <c:formatCode>General</c:formatCode>
                <c:ptCount val="2"/>
                <c:pt idx="0">
                  <c:v>1</c:v>
                </c:pt>
                <c:pt idx="1">
                  <c:v>2.04476346877152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D6-4785-984C-B87A9EC499CB}"/>
            </c:ext>
          </c:extLst>
        </c:ser>
        <c:ser>
          <c:idx val="1"/>
          <c:order val="1"/>
          <c:tx>
            <c:strRef>
              <c:f>'Raw Data-5 Hour'!$I$27</c:f>
              <c:strCache>
                <c:ptCount val="1"/>
                <c:pt idx="0">
                  <c:v>20uM GKT</c:v>
                </c:pt>
              </c:strCache>
            </c:strRef>
          </c:tx>
          <c:spPr>
            <a:solidFill>
              <a:schemeClr val="bg1"/>
            </a:solidFill>
            <a:ln w="0">
              <a:solidFill>
                <a:schemeClr val="tx1">
                  <a:lumMod val="50000"/>
                  <a:lumOff val="50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w Data-5 Hour'!$L$27:$M$27</c:f>
                <c:numCache>
                  <c:formatCode>General</c:formatCode>
                  <c:ptCount val="2"/>
                  <c:pt idx="0">
                    <c:v>9.7969041132862297E-2</c:v>
                  </c:pt>
                  <c:pt idx="1">
                    <c:v>4.9906050527697712E-2</c:v>
                  </c:pt>
                </c:numCache>
              </c:numRef>
            </c:plus>
            <c:minus>
              <c:numRef>
                <c:f>'Raw Data-5 Hour'!$L$27:$M$27</c:f>
                <c:numCache>
                  <c:formatCode>General</c:formatCode>
                  <c:ptCount val="2"/>
                  <c:pt idx="0">
                    <c:v>9.7969041132862297E-2</c:v>
                  </c:pt>
                  <c:pt idx="1">
                    <c:v>4.990605052769771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w Data-5 Hour'!$J$25:$K$25</c:f>
              <c:strCache>
                <c:ptCount val="2"/>
                <c:pt idx="0">
                  <c:v>RMF</c:v>
                </c:pt>
                <c:pt idx="1">
                  <c:v>CAF5</c:v>
                </c:pt>
              </c:strCache>
            </c:strRef>
          </c:cat>
          <c:val>
            <c:numRef>
              <c:f>'Raw Data-5 Hour'!$J$27:$K$27</c:f>
              <c:numCache>
                <c:formatCode>General</c:formatCode>
                <c:ptCount val="2"/>
                <c:pt idx="0">
                  <c:v>0.56000000000000005</c:v>
                </c:pt>
                <c:pt idx="1">
                  <c:v>1.00651586586851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3D6-4785-984C-B87A9EC499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973052976"/>
        <c:axId val="1973047984"/>
      </c:barChart>
      <c:catAx>
        <c:axId val="1973052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73047984"/>
        <c:crosses val="autoZero"/>
        <c:auto val="1"/>
        <c:lblAlgn val="ctr"/>
        <c:lblOffset val="100"/>
        <c:noMultiLvlLbl val="0"/>
      </c:catAx>
      <c:valAx>
        <c:axId val="19730479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Relative  Extracellular H</a:t>
                </a:r>
                <a:r>
                  <a:rPr lang="en-US" baseline="-25000" dirty="0"/>
                  <a:t>2</a:t>
                </a:r>
                <a:r>
                  <a:rPr lang="en-US" dirty="0"/>
                  <a:t>O</a:t>
                </a:r>
                <a:r>
                  <a:rPr lang="en-US" baseline="-25000" dirty="0"/>
                  <a:t>2</a:t>
                </a:r>
              </a:p>
            </c:rich>
          </c:tx>
          <c:layout>
            <c:manualLayout>
              <c:xMode val="edge"/>
              <c:yMode val="edge"/>
              <c:x val="2.7991602519244228E-2"/>
              <c:y val="0.112520366364094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9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73052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A7F77F43-62F2-497D-AF8E-D3D671B2A82B}" type="datetimeFigureOut">
              <a:rPr lang="en-US" smtClean="0"/>
              <a:t>5/2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4488A80D-0846-446D-9348-24BFFC735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7918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A2E3F-CB7E-422B-A36B-804C5E4AAB92}" type="datetimeFigureOut">
              <a:rPr lang="en-US" smtClean="0"/>
              <a:t>5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2B89F-878A-45A8-90E0-786260BEDC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457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A2E3F-CB7E-422B-A36B-804C5E4AAB92}" type="datetimeFigureOut">
              <a:rPr lang="en-US" smtClean="0"/>
              <a:t>5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2B89F-878A-45A8-90E0-786260BEDC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5104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A2E3F-CB7E-422B-A36B-804C5E4AAB92}" type="datetimeFigureOut">
              <a:rPr lang="en-US" smtClean="0"/>
              <a:t>5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2B89F-878A-45A8-90E0-786260BEDC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659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A2E3F-CB7E-422B-A36B-804C5E4AAB92}" type="datetimeFigureOut">
              <a:rPr lang="en-US" smtClean="0"/>
              <a:t>5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2B89F-878A-45A8-90E0-786260BEDC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82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A2E3F-CB7E-422B-A36B-804C5E4AAB92}" type="datetimeFigureOut">
              <a:rPr lang="en-US" smtClean="0"/>
              <a:t>5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2B89F-878A-45A8-90E0-786260BEDC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7065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A2E3F-CB7E-422B-A36B-804C5E4AAB92}" type="datetimeFigureOut">
              <a:rPr lang="en-US" smtClean="0"/>
              <a:t>5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2B89F-878A-45A8-90E0-786260BEDC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022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A2E3F-CB7E-422B-A36B-804C5E4AAB92}" type="datetimeFigureOut">
              <a:rPr lang="en-US" smtClean="0"/>
              <a:t>5/2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2B89F-878A-45A8-90E0-786260BEDC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35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A2E3F-CB7E-422B-A36B-804C5E4AAB92}" type="datetimeFigureOut">
              <a:rPr lang="en-US" smtClean="0"/>
              <a:t>5/2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2B89F-878A-45A8-90E0-786260BEDC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022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A2E3F-CB7E-422B-A36B-804C5E4AAB92}" type="datetimeFigureOut">
              <a:rPr lang="en-US" smtClean="0"/>
              <a:t>5/2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2B89F-878A-45A8-90E0-786260BEDC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579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A2E3F-CB7E-422B-A36B-804C5E4AAB92}" type="datetimeFigureOut">
              <a:rPr lang="en-US" smtClean="0"/>
              <a:t>5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2B89F-878A-45A8-90E0-786260BEDC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153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A2E3F-CB7E-422B-A36B-804C5E4AAB92}" type="datetimeFigureOut">
              <a:rPr lang="en-US" smtClean="0"/>
              <a:t>5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2B89F-878A-45A8-90E0-786260BEDC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387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A2E3F-CB7E-422B-A36B-804C5E4AAB92}" type="datetimeFigureOut">
              <a:rPr lang="en-US" smtClean="0"/>
              <a:t>5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2B89F-878A-45A8-90E0-786260BEDC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107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5" Type="http://schemas.openxmlformats.org/officeDocument/2006/relationships/chart" Target="../charts/chart3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878279A9-C3B6-450E-BEB3-ACBA752EE0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4883757"/>
              </p:ext>
            </p:extLst>
          </p:nvPr>
        </p:nvGraphicFramePr>
        <p:xfrm>
          <a:off x="3255835" y="3842995"/>
          <a:ext cx="1952270" cy="18764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2B0FDF23-1903-4B4B-AA28-54E4CA62A2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049862"/>
              </p:ext>
            </p:extLst>
          </p:nvPr>
        </p:nvGraphicFramePr>
        <p:xfrm>
          <a:off x="2878534" y="731510"/>
          <a:ext cx="2218022" cy="23851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1" name="Picture 10">
            <a:extLst>
              <a:ext uri="{FF2B5EF4-FFF2-40B4-BE49-F238E27FC236}">
                <a16:creationId xmlns:a16="http://schemas.microsoft.com/office/drawing/2014/main" id="{DBA66D04-6EB5-4E39-8F7A-A80EB24E84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3992" y="731511"/>
            <a:ext cx="2197511" cy="2385129"/>
          </a:xfrm>
          <a:prstGeom prst="rect">
            <a:avLst/>
          </a:prstGeom>
        </p:spPr>
      </p:pic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528B9258-AAD2-4223-A8E1-61D4E189495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8656094"/>
              </p:ext>
            </p:extLst>
          </p:nvPr>
        </p:nvGraphicFramePr>
        <p:xfrm>
          <a:off x="453992" y="5806205"/>
          <a:ext cx="2801843" cy="22042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07E0B991-3430-4CD5-BB42-03B13D5D33DC}"/>
              </a:ext>
            </a:extLst>
          </p:cNvPr>
          <p:cNvSpPr txBox="1"/>
          <p:nvPr/>
        </p:nvSpPr>
        <p:spPr>
          <a:xfrm>
            <a:off x="233535" y="447261"/>
            <a:ext cx="3528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2908268-5D28-45A8-B9FB-D414E307F070}"/>
              </a:ext>
            </a:extLst>
          </p:cNvPr>
          <p:cNvSpPr txBox="1"/>
          <p:nvPr/>
        </p:nvSpPr>
        <p:spPr>
          <a:xfrm>
            <a:off x="2871960" y="447261"/>
            <a:ext cx="3528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E43ADC8-08BB-4EC6-BECD-7AEB0C48CE50}"/>
              </a:ext>
            </a:extLst>
          </p:cNvPr>
          <p:cNvSpPr txBox="1"/>
          <p:nvPr/>
        </p:nvSpPr>
        <p:spPr>
          <a:xfrm>
            <a:off x="233535" y="3394411"/>
            <a:ext cx="220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254D02A-D8DF-4402-8B26-231708641438}"/>
              </a:ext>
            </a:extLst>
          </p:cNvPr>
          <p:cNvSpPr txBox="1"/>
          <p:nvPr/>
        </p:nvSpPr>
        <p:spPr>
          <a:xfrm>
            <a:off x="3255834" y="3394411"/>
            <a:ext cx="417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F925E49-10C4-4ECB-B90B-9EE0D16FCFEF}"/>
              </a:ext>
            </a:extLst>
          </p:cNvPr>
          <p:cNvSpPr txBox="1"/>
          <p:nvPr/>
        </p:nvSpPr>
        <p:spPr>
          <a:xfrm>
            <a:off x="233535" y="5806205"/>
            <a:ext cx="3528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7CFD0F9-75DC-4A8D-9871-A7FEFC9D3786}"/>
              </a:ext>
            </a:extLst>
          </p:cNvPr>
          <p:cNvSpPr txBox="1"/>
          <p:nvPr/>
        </p:nvSpPr>
        <p:spPr>
          <a:xfrm>
            <a:off x="4065105" y="1463469"/>
            <a:ext cx="183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FC8E71B-E442-4AA7-B56E-D738F77AE417}"/>
              </a:ext>
            </a:extLst>
          </p:cNvPr>
          <p:cNvSpPr txBox="1"/>
          <p:nvPr/>
        </p:nvSpPr>
        <p:spPr>
          <a:xfrm>
            <a:off x="4624904" y="2037782"/>
            <a:ext cx="109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#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31ACB5D-D712-49CD-AFD0-38D5780D097C}"/>
              </a:ext>
            </a:extLst>
          </p:cNvPr>
          <p:cNvSpPr txBox="1"/>
          <p:nvPr/>
        </p:nvSpPr>
        <p:spPr>
          <a:xfrm>
            <a:off x="2319132" y="5969102"/>
            <a:ext cx="183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3C646AC-3521-4510-9827-43CB5E164090}"/>
              </a:ext>
            </a:extLst>
          </p:cNvPr>
          <p:cNvSpPr txBox="1"/>
          <p:nvPr/>
        </p:nvSpPr>
        <p:spPr>
          <a:xfrm>
            <a:off x="1532869" y="6813105"/>
            <a:ext cx="183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021695E-8334-4EA0-BB90-07CF3D64BF20}"/>
              </a:ext>
            </a:extLst>
          </p:cNvPr>
          <p:cNvSpPr txBox="1"/>
          <p:nvPr/>
        </p:nvSpPr>
        <p:spPr>
          <a:xfrm>
            <a:off x="2641564" y="6536106"/>
            <a:ext cx="109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#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96D6380-0364-4A77-BDEC-4B79D68D2C41}"/>
              </a:ext>
            </a:extLst>
          </p:cNvPr>
          <p:cNvSpPr txBox="1"/>
          <p:nvPr/>
        </p:nvSpPr>
        <p:spPr>
          <a:xfrm>
            <a:off x="4470925" y="3937241"/>
            <a:ext cx="183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4F4925F8-D798-40E3-8444-5D9077914D1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6298"/>
          <a:stretch/>
        </p:blipFill>
        <p:spPr>
          <a:xfrm>
            <a:off x="343763" y="3491245"/>
            <a:ext cx="2801843" cy="2314959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A94275C2-7DC8-43F7-A646-5FA215605540}"/>
              </a:ext>
            </a:extLst>
          </p:cNvPr>
          <p:cNvSpPr txBox="1"/>
          <p:nvPr/>
        </p:nvSpPr>
        <p:spPr>
          <a:xfrm>
            <a:off x="4801668" y="4859707"/>
            <a:ext cx="109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#</a:t>
            </a:r>
          </a:p>
        </p:txBody>
      </p:sp>
    </p:spTree>
    <p:extLst>
      <p:ext uri="{BB962C8B-B14F-4D97-AF65-F5344CB8AC3E}">
        <p14:creationId xmlns:p14="http://schemas.microsoft.com/office/powerpoint/2010/main" val="809639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926</TotalTime>
  <Words>24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oh-Fitzgerald, Melissa M</dc:creator>
  <cp:lastModifiedBy>Teoh-Fitzgerald, Melissa</cp:lastModifiedBy>
  <cp:revision>250</cp:revision>
  <cp:lastPrinted>2020-09-01T21:29:25Z</cp:lastPrinted>
  <dcterms:created xsi:type="dcterms:W3CDTF">2017-05-16T17:57:36Z</dcterms:created>
  <dcterms:modified xsi:type="dcterms:W3CDTF">2022-05-26T20:28:08Z</dcterms:modified>
</cp:coreProperties>
</file>